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660"/>
  </p:normalViewPr>
  <p:slideViewPr>
    <p:cSldViewPr snapToGrid="0">
      <p:cViewPr varScale="1">
        <p:scale>
          <a:sx n="81" d="100"/>
          <a:sy n="81" d="100"/>
        </p:scale>
        <p:origin x="494" y="7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ladn\Desktop\Pl%20transcriptom\Data%20sorting\PlLPAT%20family\PlLPAT%20famil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ladn\Desktop\Pl%20transcriptom\Data%20sorting\PlLPAT%20family\PlLPAT%20famil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ladn\Desktop\Pl%20transcriptom\Data%20sorting\PlLPAT%20family\PlLPAT%20family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ladn\Desktop\Pl%20transcriptom\Data%20sorting\PlLPAT%20family\PlLPAT%20family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ladn\Desktop\Pl%20transcriptom\Data%20sorting\PlLPAT%20family\PlLPAT%20family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1905399361578226"/>
          <c:y val="8.671754218787620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ko-KR" sz="105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1"/>
        <c:ser>
          <c:idx val="0"/>
          <c:order val="0"/>
          <c:tx>
            <c:strRef>
              <c:f>Table!$P$3</c:f>
              <c:strCache>
                <c:ptCount val="1"/>
                <c:pt idx="0">
                  <c:v>LPAT1 (c57562_g1_i2) 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D82-4BAD-A41E-B628790856D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D82-4BAD-A41E-B628790856DA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D82-4BAD-A41E-B628790856DA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D82-4BAD-A41E-B628790856DA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D82-4BAD-A41E-B628790856DA}"/>
              </c:ext>
            </c:extLst>
          </c:dPt>
          <c:cat>
            <c:strRef>
              <c:f>Table!$Q$2:$U$2</c:f>
              <c:strCache>
                <c:ptCount val="5"/>
                <c:pt idx="0">
                  <c:v>21</c:v>
                </c:pt>
                <c:pt idx="1">
                  <c:v>35</c:v>
                </c:pt>
                <c:pt idx="2">
                  <c:v>42</c:v>
                </c:pt>
                <c:pt idx="3">
                  <c:v>flower bud</c:v>
                </c:pt>
                <c:pt idx="4">
                  <c:v>leaf</c:v>
                </c:pt>
              </c:strCache>
            </c:strRef>
          </c:cat>
          <c:val>
            <c:numRef>
              <c:f>Table!$Q$3:$U$3</c:f>
              <c:numCache>
                <c:formatCode>0.0</c:formatCode>
                <c:ptCount val="5"/>
                <c:pt idx="0">
                  <c:v>2.75060204</c:v>
                </c:pt>
                <c:pt idx="1">
                  <c:v>3.1568599800000001</c:v>
                </c:pt>
                <c:pt idx="2">
                  <c:v>2.8941956900000001</c:v>
                </c:pt>
                <c:pt idx="3">
                  <c:v>3.4824642699999999</c:v>
                </c:pt>
                <c:pt idx="4">
                  <c:v>3.49336346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D82-4BAD-A41E-B628790856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019684080"/>
        <c:axId val="-1019683536"/>
      </c:barChart>
      <c:catAx>
        <c:axId val="-1019684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ko-KR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019683536"/>
        <c:crosses val="autoZero"/>
        <c:auto val="1"/>
        <c:lblAlgn val="ctr"/>
        <c:lblOffset val="100"/>
        <c:noMultiLvlLbl val="0"/>
      </c:catAx>
      <c:valAx>
        <c:axId val="-101968353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ko-KR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019684080"/>
        <c:crosses val="autoZero"/>
        <c:crossBetween val="between"/>
        <c:majorUnit val="1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en-US" altLang="ko-KR" sz="10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1223910374462857"/>
          <c:y val="7.49136776717022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ko-KR" sz="105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477542459586657"/>
          <c:y val="0.21740303183214618"/>
          <c:w val="0.74375946388377323"/>
          <c:h val="0.57074945316232784"/>
        </c:manualLayout>
      </c:layout>
      <c:barChart>
        <c:barDir val="col"/>
        <c:grouping val="clustered"/>
        <c:varyColors val="1"/>
        <c:ser>
          <c:idx val="0"/>
          <c:order val="0"/>
          <c:tx>
            <c:strRef>
              <c:f>Table!$P$4</c:f>
              <c:strCache>
                <c:ptCount val="1"/>
                <c:pt idx="0">
                  <c:v>LPAT2 (c53827_g2_i7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DB6-4C79-8DAA-4F26A88BA2D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DB6-4C79-8DAA-4F26A88BA2D3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DB6-4C79-8DAA-4F26A88BA2D3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DB6-4C79-8DAA-4F26A88BA2D3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EDB6-4C79-8DAA-4F26A88BA2D3}"/>
              </c:ext>
            </c:extLst>
          </c:dPt>
          <c:cat>
            <c:strRef>
              <c:f>Table!$Q$2:$U$2</c:f>
              <c:strCache>
                <c:ptCount val="5"/>
                <c:pt idx="0">
                  <c:v>21</c:v>
                </c:pt>
                <c:pt idx="1">
                  <c:v>35</c:v>
                </c:pt>
                <c:pt idx="2">
                  <c:v>42</c:v>
                </c:pt>
                <c:pt idx="3">
                  <c:v>flower bud</c:v>
                </c:pt>
                <c:pt idx="4">
                  <c:v>leaf</c:v>
                </c:pt>
              </c:strCache>
            </c:strRef>
          </c:cat>
          <c:val>
            <c:numRef>
              <c:f>Table!$Q$4:$U$4</c:f>
              <c:numCache>
                <c:formatCode>0.0</c:formatCode>
                <c:ptCount val="5"/>
                <c:pt idx="0">
                  <c:v>3.7698603799999999</c:v>
                </c:pt>
                <c:pt idx="1">
                  <c:v>4.3832426299999998</c:v>
                </c:pt>
                <c:pt idx="2">
                  <c:v>4.1431378499999996</c:v>
                </c:pt>
                <c:pt idx="3">
                  <c:v>4.3145285700000002</c:v>
                </c:pt>
                <c:pt idx="4">
                  <c:v>4.21635587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EDB6-4C79-8DAA-4F26A88BA2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042391872"/>
        <c:axId val="-1042388064"/>
      </c:barChart>
      <c:catAx>
        <c:axId val="-1042391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ko-KR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042388064"/>
        <c:crosses val="autoZero"/>
        <c:auto val="1"/>
        <c:lblAlgn val="ctr"/>
        <c:lblOffset val="100"/>
        <c:noMultiLvlLbl val="0"/>
      </c:catAx>
      <c:valAx>
        <c:axId val="-104238806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ko-KR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042391872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lang="en-US" altLang="ko-KR" sz="10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17499147263116963"/>
          <c:y val="8.002520478890989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ko-KR" sz="105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692487590683467"/>
          <c:y val="0.21886893509766855"/>
          <c:w val="0.77427596410843835"/>
          <c:h val="0.57368725057760972"/>
        </c:manualLayout>
      </c:layout>
      <c:barChart>
        <c:barDir val="col"/>
        <c:grouping val="clustered"/>
        <c:varyColors val="1"/>
        <c:ser>
          <c:idx val="0"/>
          <c:order val="0"/>
          <c:tx>
            <c:strRef>
              <c:f>Table!$P$5</c:f>
              <c:strCache>
                <c:ptCount val="1"/>
                <c:pt idx="0">
                  <c:v>LPAT3 (c57511_g1_i2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9CD-49FE-BBCF-9A9C966130CA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9CD-49FE-BBCF-9A9C966130C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9CD-49FE-BBCF-9A9C966130CA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9CD-49FE-BBCF-9A9C966130CA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9CD-49FE-BBCF-9A9C966130CA}"/>
              </c:ext>
            </c:extLst>
          </c:dPt>
          <c:cat>
            <c:strRef>
              <c:f>Table!$Q$2:$U$2</c:f>
              <c:strCache>
                <c:ptCount val="5"/>
                <c:pt idx="0">
                  <c:v>21</c:v>
                </c:pt>
                <c:pt idx="1">
                  <c:v>35</c:v>
                </c:pt>
                <c:pt idx="2">
                  <c:v>42</c:v>
                </c:pt>
                <c:pt idx="3">
                  <c:v>flower bud</c:v>
                </c:pt>
                <c:pt idx="4">
                  <c:v>leaf</c:v>
                </c:pt>
              </c:strCache>
            </c:strRef>
          </c:cat>
          <c:val>
            <c:numRef>
              <c:f>Table!$Q$5:$U$5</c:f>
              <c:numCache>
                <c:formatCode>0.0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3739831658850965</c:v>
                </c:pt>
                <c:pt idx="4">
                  <c:v>1.36644680665006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D9CD-49FE-BBCF-9A9C966130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921567008"/>
        <c:axId val="-921568640"/>
      </c:barChart>
      <c:catAx>
        <c:axId val="-921567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ko-KR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921568640"/>
        <c:crosses val="autoZero"/>
        <c:auto val="1"/>
        <c:lblAlgn val="ctr"/>
        <c:lblOffset val="100"/>
        <c:noMultiLvlLbl val="0"/>
      </c:catAx>
      <c:valAx>
        <c:axId val="-9215686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ko-KR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921567008"/>
        <c:crosses val="autoZero"/>
        <c:crossBetween val="between"/>
        <c:majorUnit val="0.30000000000000004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lang="en-US" altLang="ko-KR" sz="10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19037241661551055"/>
          <c:y val="7.806293887948516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ko-KR" sz="105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1"/>
        <c:ser>
          <c:idx val="0"/>
          <c:order val="0"/>
          <c:tx>
            <c:strRef>
              <c:f>Table!$P$6</c:f>
              <c:strCache>
                <c:ptCount val="1"/>
                <c:pt idx="0">
                  <c:v>LPAT4 (c60254_g4_i1)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0D7-4FED-BC78-5DFA8DB46251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0D7-4FED-BC78-5DFA8DB46251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0D7-4FED-BC78-5DFA8DB46251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0D7-4FED-BC78-5DFA8DB46251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0D7-4FED-BC78-5DFA8DB46251}"/>
              </c:ext>
            </c:extLst>
          </c:dPt>
          <c:cat>
            <c:strRef>
              <c:f>Table!$Q$2:$U$2</c:f>
              <c:strCache>
                <c:ptCount val="5"/>
                <c:pt idx="0">
                  <c:v>21</c:v>
                </c:pt>
                <c:pt idx="1">
                  <c:v>35</c:v>
                </c:pt>
                <c:pt idx="2">
                  <c:v>42</c:v>
                </c:pt>
                <c:pt idx="3">
                  <c:v>flower bud</c:v>
                </c:pt>
                <c:pt idx="4">
                  <c:v>leaf</c:v>
                </c:pt>
              </c:strCache>
            </c:strRef>
          </c:cat>
          <c:val>
            <c:numRef>
              <c:f>Table!$Q$6:$U$6</c:f>
              <c:numCache>
                <c:formatCode>0.0</c:formatCode>
                <c:ptCount val="5"/>
                <c:pt idx="0">
                  <c:v>0.81068845</c:v>
                </c:pt>
                <c:pt idx="1">
                  <c:v>1.0961410700000001</c:v>
                </c:pt>
                <c:pt idx="2">
                  <c:v>0.99117822</c:v>
                </c:pt>
                <c:pt idx="3">
                  <c:v>1.0819438100000001</c:v>
                </c:pt>
                <c:pt idx="4">
                  <c:v>0.863993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0D7-4FED-BC78-5DFA8DB462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921576256"/>
        <c:axId val="-921578976"/>
      </c:barChart>
      <c:catAx>
        <c:axId val="-921576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ko-KR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921578976"/>
        <c:crosses val="autoZero"/>
        <c:auto val="1"/>
        <c:lblAlgn val="ctr"/>
        <c:lblOffset val="100"/>
        <c:noMultiLvlLbl val="0"/>
      </c:catAx>
      <c:valAx>
        <c:axId val="-92157897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ko-KR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92157625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lang="en-US" altLang="ko-KR" sz="10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19265333943303481"/>
          <c:y val="7.22833415617239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ko-KR" sz="105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1"/>
        <c:ser>
          <c:idx val="0"/>
          <c:order val="0"/>
          <c:tx>
            <c:strRef>
              <c:f>Table!$P$7</c:f>
              <c:strCache>
                <c:ptCount val="1"/>
                <c:pt idx="0">
                  <c:v>LPAT5 (c55875_g1_i3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80C-4F2B-9C13-81DCD3D28DF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80C-4F2B-9C13-81DCD3D28DFD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80C-4F2B-9C13-81DCD3D28DFD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80C-4F2B-9C13-81DCD3D28DFD}"/>
              </c:ext>
            </c:extLst>
          </c:dPt>
          <c:dPt>
            <c:idx val="4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80C-4F2B-9C13-81DCD3D28DFD}"/>
              </c:ext>
            </c:extLst>
          </c:dPt>
          <c:cat>
            <c:strRef>
              <c:f>Table!$Q$2:$U$2</c:f>
              <c:strCache>
                <c:ptCount val="5"/>
                <c:pt idx="0">
                  <c:v>21</c:v>
                </c:pt>
                <c:pt idx="1">
                  <c:v>35</c:v>
                </c:pt>
                <c:pt idx="2">
                  <c:v>42</c:v>
                </c:pt>
                <c:pt idx="3">
                  <c:v>flower bud</c:v>
                </c:pt>
                <c:pt idx="4">
                  <c:v>leaf</c:v>
                </c:pt>
              </c:strCache>
            </c:strRef>
          </c:cat>
          <c:val>
            <c:numRef>
              <c:f>Table!$Q$7:$U$7</c:f>
              <c:numCache>
                <c:formatCode>0.0</c:formatCode>
                <c:ptCount val="5"/>
                <c:pt idx="0">
                  <c:v>0.71104637000000004</c:v>
                </c:pt>
                <c:pt idx="1">
                  <c:v>0.78319338000000005</c:v>
                </c:pt>
                <c:pt idx="2">
                  <c:v>0.79455105999999998</c:v>
                </c:pt>
                <c:pt idx="3">
                  <c:v>2.910406</c:v>
                </c:pt>
                <c:pt idx="4">
                  <c:v>2.97928124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D80C-4F2B-9C13-81DCD3D28D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921566464"/>
        <c:axId val="-921577344"/>
      </c:barChart>
      <c:catAx>
        <c:axId val="-921566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ko-KR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921577344"/>
        <c:crosses val="autoZero"/>
        <c:auto val="1"/>
        <c:lblAlgn val="ctr"/>
        <c:lblOffset val="100"/>
        <c:noMultiLvlLbl val="0"/>
      </c:catAx>
      <c:valAx>
        <c:axId val="-92157734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altLang="ko-KR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92156646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lang="en-US" altLang="ko-KR" sz="1000" b="0" i="0" u="none" strike="noStrike" kern="1200" baseline="0">
          <a:solidFill>
            <a:schemeClr val="tx1"/>
          </a:solidFill>
          <a:latin typeface="+mn-lt"/>
          <a:ea typeface="+mn-ea"/>
          <a:cs typeface="+mn-cs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5859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2016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2347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0164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8824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1264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1611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8201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1578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8274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3874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A60EB3-1FFF-4671-BA1C-EB5D331B1BFF}" type="datetimeFigureOut">
              <a:rPr lang="ko-KR" altLang="en-US" smtClean="0"/>
              <a:t>2020-12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F71BF2-92F3-40B5-8653-26573DF085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1539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4432686"/>
              </p:ext>
            </p:extLst>
          </p:nvPr>
        </p:nvGraphicFramePr>
        <p:xfrm>
          <a:off x="521017" y="5408919"/>
          <a:ext cx="5915030" cy="18055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377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773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773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773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773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773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3773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3773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3773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3773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53773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1625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AtLPA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AtLPA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AtLPAT3.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AtLPAT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AtLPAT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PlLPA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PlLPA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PlLPAT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PlLPAT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PlLPAT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430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0</a:t>
                      </a:r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1.5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1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1.8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.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83.1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1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.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1.2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.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AtLPA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4306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r>
                        <a:rPr lang="en-US" altLang="ko-KR" sz="1000" b="0" u="none" strike="noStrike" dirty="0">
                          <a:effectLst/>
                        </a:rPr>
                        <a:t>100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57.4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24.9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2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10.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93.1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57.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27.1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24.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AtLPA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4306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0</a:t>
                      </a:r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22.9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22.1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10.6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57.7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89.6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22.5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23.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AtLPAT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4306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0</a:t>
                      </a:r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54.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.3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25.7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23.8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87.9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53.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AtLPAT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4306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0</a:t>
                      </a:r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.6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24.3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22.7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52.5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85.1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AtLPAT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4306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0</a:t>
                      </a:r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11.4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12.5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10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PlLPAT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4306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0</a:t>
                      </a:r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57.8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28.3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>
                          <a:effectLst/>
                        </a:rPr>
                        <a:t>24.9</a:t>
                      </a:r>
                      <a:endParaRPr lang="en-US" altLang="ko-KR" sz="10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PlLPAT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4306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r>
                        <a:rPr lang="en-US" altLang="ko-KR" sz="1000" b="0" u="none" strike="noStrike" dirty="0">
                          <a:effectLst/>
                        </a:rPr>
                        <a:t>100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24.2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24.1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PlLPAT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4306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100</a:t>
                      </a:r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u="none" strike="noStrike" dirty="0">
                          <a:effectLst/>
                        </a:rPr>
                        <a:t>51.7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PlLPAT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4306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u="none" strike="noStrike" dirty="0">
                          <a:effectLst/>
                        </a:rPr>
                        <a:t>　</a:t>
                      </a:r>
                      <a:r>
                        <a:rPr lang="en-US" altLang="ko-KR" sz="1000" b="0" u="none" strike="noStrike" dirty="0">
                          <a:effectLst/>
                        </a:rPr>
                        <a:t>100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u="none" strike="noStrike" dirty="0">
                          <a:effectLst/>
                        </a:rPr>
                        <a:t>PlLPAT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7468" marR="7468" marT="7468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630998" y="7898310"/>
            <a:ext cx="606162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9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haracterization of 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lLPAT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gene family. (A) Relative expression of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PlLPAT2s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n developing seeds, flower bud, and leaf. DAP, days after pollination. ND, not detected. (B) Percent similarity of amino acid sequences.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Arabidopsis thalian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Pl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hysaria</a:t>
            </a:r>
            <a:r>
              <a:rPr lang="en-US" altLang="ko-KR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lindheimeri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enbank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ccession number</a:t>
            </a: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: AtLPAT1, AT4G30580; AtLPAT2, AT3G57650; AtLPAT3, AT1G51260; AtLPAT4, AT1G75020; AtLPAT5, AT3G18850.</a:t>
            </a:r>
            <a:endParaRPr lang="en-US" altLang="ko-KR" sz="1200" dirty="0">
              <a:highlight>
                <a:srgbClr val="FF00FF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C607658-9D16-4BD8-BEAE-56B01692FC5A}"/>
              </a:ext>
            </a:extLst>
          </p:cNvPr>
          <p:cNvGrpSpPr/>
          <p:nvPr/>
        </p:nvGrpSpPr>
        <p:grpSpPr>
          <a:xfrm>
            <a:off x="386244" y="969032"/>
            <a:ext cx="6170125" cy="3885035"/>
            <a:chOff x="296597" y="3434327"/>
            <a:chExt cx="6170125" cy="3885035"/>
          </a:xfrm>
        </p:grpSpPr>
        <p:grpSp>
          <p:nvGrpSpPr>
            <p:cNvPr id="22" name="그룹 21">
              <a:extLst>
                <a:ext uri="{FF2B5EF4-FFF2-40B4-BE49-F238E27FC236}">
                  <a16:creationId xmlns:a16="http://schemas.microsoft.com/office/drawing/2014/main" id="{ACBA1045-C707-488C-95C6-F65250A822F2}"/>
                </a:ext>
              </a:extLst>
            </p:cNvPr>
            <p:cNvGrpSpPr/>
            <p:nvPr/>
          </p:nvGrpSpPr>
          <p:grpSpPr>
            <a:xfrm>
              <a:off x="296597" y="3434327"/>
              <a:ext cx="2088967" cy="1921339"/>
              <a:chOff x="675513" y="4339635"/>
              <a:chExt cx="2088967" cy="1899925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8F035947-6110-4DBB-A56C-AC2D32B68F93}"/>
                  </a:ext>
                </a:extLst>
              </p:cNvPr>
              <p:cNvSpPr txBox="1"/>
              <p:nvPr/>
            </p:nvSpPr>
            <p:spPr>
              <a:xfrm rot="16200000">
                <a:off x="169232" y="5082308"/>
                <a:ext cx="121261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ized Expression</a:t>
                </a:r>
              </a:p>
            </p:txBody>
          </p:sp>
          <p:graphicFrame>
            <p:nvGraphicFramePr>
              <p:cNvPr id="8" name="차트 7">
                <a:extLst>
                  <a:ext uri="{FF2B5EF4-FFF2-40B4-BE49-F238E27FC236}">
                    <a16:creationId xmlns:a16="http://schemas.microsoft.com/office/drawing/2014/main" id="{382A488A-EC1D-4E58-AB20-FB86BBDAB0D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02589325"/>
                  </p:ext>
                </p:extLst>
              </p:nvPr>
            </p:nvGraphicFramePr>
            <p:xfrm>
              <a:off x="810286" y="4339635"/>
              <a:ext cx="1954194" cy="186481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pSp>
            <p:nvGrpSpPr>
              <p:cNvPr id="3" name="그룹 2">
                <a:extLst>
                  <a:ext uri="{FF2B5EF4-FFF2-40B4-BE49-F238E27FC236}">
                    <a16:creationId xmlns:a16="http://schemas.microsoft.com/office/drawing/2014/main" id="{6519DD1D-E326-4434-B4AC-7C56A5E47C82}"/>
                  </a:ext>
                </a:extLst>
              </p:cNvPr>
              <p:cNvGrpSpPr/>
              <p:nvPr/>
            </p:nvGrpSpPr>
            <p:grpSpPr>
              <a:xfrm>
                <a:off x="1011884" y="6039505"/>
                <a:ext cx="1178528" cy="200055"/>
                <a:chOff x="594214" y="6785097"/>
                <a:chExt cx="2099803" cy="200055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846CBD89-45AD-4CE5-A77D-6A2B72A4940A}"/>
                    </a:ext>
                  </a:extLst>
                </p:cNvPr>
                <p:cNvSpPr txBox="1"/>
                <p:nvPr/>
              </p:nvSpPr>
              <p:spPr>
                <a:xfrm>
                  <a:off x="594214" y="6785097"/>
                  <a:ext cx="2099803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veloping Seeds (DAP)</a:t>
                  </a:r>
                </a:p>
              </p:txBody>
            </p:sp>
            <p:cxnSp>
              <p:nvCxnSpPr>
                <p:cNvPr id="11" name="Straight Connector 9">
                  <a:extLst>
                    <a:ext uri="{FF2B5EF4-FFF2-40B4-BE49-F238E27FC236}">
                      <a16:creationId xmlns:a16="http://schemas.microsoft.com/office/drawing/2014/main" id="{8C3C2157-1A0B-4BB8-AD63-1F90ED87938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61075" y="6785097"/>
                  <a:ext cx="130078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7" name="그룹 16">
              <a:extLst>
                <a:ext uri="{FF2B5EF4-FFF2-40B4-BE49-F238E27FC236}">
                  <a16:creationId xmlns:a16="http://schemas.microsoft.com/office/drawing/2014/main" id="{C22A2C26-4DAF-4032-AC51-37743AE04634}"/>
                </a:ext>
              </a:extLst>
            </p:cNvPr>
            <p:cNvGrpSpPr/>
            <p:nvPr/>
          </p:nvGrpSpPr>
          <p:grpSpPr>
            <a:xfrm>
              <a:off x="2334940" y="3449566"/>
              <a:ext cx="2086677" cy="1945394"/>
              <a:chOff x="2632603" y="4354133"/>
              <a:chExt cx="2086677" cy="1903257"/>
            </a:xfrm>
          </p:grpSpPr>
          <p:graphicFrame>
            <p:nvGraphicFramePr>
              <p:cNvPr id="9" name="차트 8">
                <a:extLst>
                  <a:ext uri="{FF2B5EF4-FFF2-40B4-BE49-F238E27FC236}">
                    <a16:creationId xmlns:a16="http://schemas.microsoft.com/office/drawing/2014/main" id="{F0BE010D-50C6-4ABC-9511-476FECC014B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52495350"/>
                  </p:ext>
                </p:extLst>
              </p:nvPr>
            </p:nvGraphicFramePr>
            <p:xfrm>
              <a:off x="2764480" y="4354133"/>
              <a:ext cx="1954800" cy="186481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73AAFA2-69D0-4BB3-BF66-7618692EFF06}"/>
                  </a:ext>
                </a:extLst>
              </p:cNvPr>
              <p:cNvSpPr txBox="1"/>
              <p:nvPr/>
            </p:nvSpPr>
            <p:spPr>
              <a:xfrm rot="16200000">
                <a:off x="2126322" y="5100138"/>
                <a:ext cx="121261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ized Expression</a:t>
                </a:r>
              </a:p>
            </p:txBody>
          </p:sp>
          <p:grpSp>
            <p:nvGrpSpPr>
              <p:cNvPr id="19" name="그룹 18">
                <a:extLst>
                  <a:ext uri="{FF2B5EF4-FFF2-40B4-BE49-F238E27FC236}">
                    <a16:creationId xmlns:a16="http://schemas.microsoft.com/office/drawing/2014/main" id="{464939F2-6E9C-4CC4-9ADD-84458FE1EF3B}"/>
                  </a:ext>
                </a:extLst>
              </p:cNvPr>
              <p:cNvGrpSpPr/>
              <p:nvPr/>
            </p:nvGrpSpPr>
            <p:grpSpPr>
              <a:xfrm>
                <a:off x="2976594" y="6057335"/>
                <a:ext cx="1178528" cy="200055"/>
                <a:chOff x="594214" y="6785097"/>
                <a:chExt cx="2099803" cy="200055"/>
              </a:xfrm>
            </p:grpSpPr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547788B1-C92F-4025-8975-DBAE88C6064B}"/>
                    </a:ext>
                  </a:extLst>
                </p:cNvPr>
                <p:cNvSpPr txBox="1"/>
                <p:nvPr/>
              </p:nvSpPr>
              <p:spPr>
                <a:xfrm>
                  <a:off x="594214" y="6785097"/>
                  <a:ext cx="2099803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veloping Seeds (DAP)</a:t>
                  </a:r>
                </a:p>
              </p:txBody>
            </p:sp>
            <p:cxnSp>
              <p:nvCxnSpPr>
                <p:cNvPr id="21" name="Straight Connector 9">
                  <a:extLst>
                    <a:ext uri="{FF2B5EF4-FFF2-40B4-BE49-F238E27FC236}">
                      <a16:creationId xmlns:a16="http://schemas.microsoft.com/office/drawing/2014/main" id="{0BAB4C96-4AC4-479A-A91B-DF2B86E9E23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61075" y="6785097"/>
                  <a:ext cx="130078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3" name="그룹 32">
              <a:extLst>
                <a:ext uri="{FF2B5EF4-FFF2-40B4-BE49-F238E27FC236}">
                  <a16:creationId xmlns:a16="http://schemas.microsoft.com/office/drawing/2014/main" id="{7485CB37-87E4-4BE2-8F76-D242DD7053C6}"/>
                </a:ext>
              </a:extLst>
            </p:cNvPr>
            <p:cNvGrpSpPr/>
            <p:nvPr/>
          </p:nvGrpSpPr>
          <p:grpSpPr>
            <a:xfrm>
              <a:off x="4372650" y="3445536"/>
              <a:ext cx="2094072" cy="1976992"/>
              <a:chOff x="4321009" y="4022755"/>
              <a:chExt cx="2106215" cy="1951577"/>
            </a:xfrm>
          </p:grpSpPr>
          <p:graphicFrame>
            <p:nvGraphicFramePr>
              <p:cNvPr id="23" name="차트 22">
                <a:extLst>
                  <a:ext uri="{FF2B5EF4-FFF2-40B4-BE49-F238E27FC236}">
                    <a16:creationId xmlns:a16="http://schemas.microsoft.com/office/drawing/2014/main" id="{6496DD92-226F-4207-B2E1-3AE599CE1E41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96141474"/>
                  </p:ext>
                </p:extLst>
              </p:nvPr>
            </p:nvGraphicFramePr>
            <p:xfrm>
              <a:off x="4501073" y="4022755"/>
              <a:ext cx="1926151" cy="19044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2137E49C-BD01-4A5A-AC9D-9C4A5D012A6D}"/>
                  </a:ext>
                </a:extLst>
              </p:cNvPr>
              <p:cNvSpPr txBox="1"/>
              <p:nvPr/>
            </p:nvSpPr>
            <p:spPr>
              <a:xfrm rot="16200000">
                <a:off x="3815308" y="4778401"/>
                <a:ext cx="1212618" cy="2012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ized Expression</a:t>
                </a:r>
              </a:p>
            </p:txBody>
          </p:sp>
          <p:grpSp>
            <p:nvGrpSpPr>
              <p:cNvPr id="30" name="그룹 29">
                <a:extLst>
                  <a:ext uri="{FF2B5EF4-FFF2-40B4-BE49-F238E27FC236}">
                    <a16:creationId xmlns:a16="http://schemas.microsoft.com/office/drawing/2014/main" id="{2CBAF575-C30D-48F4-9859-B283921F395E}"/>
                  </a:ext>
                </a:extLst>
              </p:cNvPr>
              <p:cNvGrpSpPr/>
              <p:nvPr/>
            </p:nvGrpSpPr>
            <p:grpSpPr>
              <a:xfrm>
                <a:off x="4642760" y="5774277"/>
                <a:ext cx="1178528" cy="200055"/>
                <a:chOff x="4658000" y="5736177"/>
                <a:chExt cx="1178528" cy="200055"/>
              </a:xfrm>
            </p:grpSpPr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4C7E7B80-7EEE-4516-92D7-27615752B154}"/>
                    </a:ext>
                  </a:extLst>
                </p:cNvPr>
                <p:cNvSpPr txBox="1"/>
                <p:nvPr/>
              </p:nvSpPr>
              <p:spPr>
                <a:xfrm>
                  <a:off x="4658000" y="5736177"/>
                  <a:ext cx="117852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veloping Seeds (DAP)</a:t>
                  </a:r>
                </a:p>
              </p:txBody>
            </p:sp>
            <p:cxnSp>
              <p:nvCxnSpPr>
                <p:cNvPr id="32" name="Straight Connector 9">
                  <a:extLst>
                    <a:ext uri="{FF2B5EF4-FFF2-40B4-BE49-F238E27FC236}">
                      <a16:creationId xmlns:a16="http://schemas.microsoft.com/office/drawing/2014/main" id="{31098A7E-EF3F-478B-80FA-99D471F183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863903" y="5736177"/>
                  <a:ext cx="73007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3" name="그룹 52">
              <a:extLst>
                <a:ext uri="{FF2B5EF4-FFF2-40B4-BE49-F238E27FC236}">
                  <a16:creationId xmlns:a16="http://schemas.microsoft.com/office/drawing/2014/main" id="{8B02CFF7-631C-4650-A4F1-B502A33461F2}"/>
                </a:ext>
              </a:extLst>
            </p:cNvPr>
            <p:cNvGrpSpPr/>
            <p:nvPr/>
          </p:nvGrpSpPr>
          <p:grpSpPr>
            <a:xfrm>
              <a:off x="1213976" y="5370687"/>
              <a:ext cx="2082006" cy="1948675"/>
              <a:chOff x="1213976" y="5881227"/>
              <a:chExt cx="2082006" cy="1948675"/>
            </a:xfrm>
          </p:grpSpPr>
          <p:graphicFrame>
            <p:nvGraphicFramePr>
              <p:cNvPr id="36" name="차트 35">
                <a:extLst>
                  <a:ext uri="{FF2B5EF4-FFF2-40B4-BE49-F238E27FC236}">
                    <a16:creationId xmlns:a16="http://schemas.microsoft.com/office/drawing/2014/main" id="{589581AE-4612-4BCD-8117-99898640B28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99529065"/>
                  </p:ext>
                </p:extLst>
              </p:nvPr>
            </p:nvGraphicFramePr>
            <p:xfrm>
              <a:off x="1341182" y="5881227"/>
              <a:ext cx="1954800" cy="190940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24E47EDB-0CF4-4E01-AF78-2F34CD63083F}"/>
                  </a:ext>
                </a:extLst>
              </p:cNvPr>
              <p:cNvSpPr txBox="1"/>
              <p:nvPr/>
            </p:nvSpPr>
            <p:spPr>
              <a:xfrm rot="16200000">
                <a:off x="700861" y="6628875"/>
                <a:ext cx="122628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ized Expression</a:t>
                </a:r>
              </a:p>
            </p:txBody>
          </p:sp>
          <p:grpSp>
            <p:nvGrpSpPr>
              <p:cNvPr id="46" name="그룹 45">
                <a:extLst>
                  <a:ext uri="{FF2B5EF4-FFF2-40B4-BE49-F238E27FC236}">
                    <a16:creationId xmlns:a16="http://schemas.microsoft.com/office/drawing/2014/main" id="{DD7EB6E8-B6D9-4FFC-B4D3-18CA90AF5647}"/>
                  </a:ext>
                </a:extLst>
              </p:cNvPr>
              <p:cNvGrpSpPr/>
              <p:nvPr/>
            </p:nvGrpSpPr>
            <p:grpSpPr>
              <a:xfrm>
                <a:off x="1539749" y="7627592"/>
                <a:ext cx="1178528" cy="202310"/>
                <a:chOff x="1288289" y="7612352"/>
                <a:chExt cx="1178528" cy="202310"/>
              </a:xfrm>
            </p:grpSpPr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845206F9-D6DB-45C0-9948-8F080FBD8BBE}"/>
                    </a:ext>
                  </a:extLst>
                </p:cNvPr>
                <p:cNvSpPr txBox="1"/>
                <p:nvPr/>
              </p:nvSpPr>
              <p:spPr>
                <a:xfrm>
                  <a:off x="1288289" y="7612352"/>
                  <a:ext cx="1178528" cy="2023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veloping Seeds (DAP)</a:t>
                  </a:r>
                </a:p>
              </p:txBody>
            </p:sp>
            <p:cxnSp>
              <p:nvCxnSpPr>
                <p:cNvPr id="48" name="Straight Connector 9">
                  <a:extLst>
                    <a:ext uri="{FF2B5EF4-FFF2-40B4-BE49-F238E27FC236}">
                      <a16:creationId xmlns:a16="http://schemas.microsoft.com/office/drawing/2014/main" id="{F2667AFB-D2C0-450E-BDA3-005274F9FCE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94192" y="7612352"/>
                  <a:ext cx="73007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9" name="그룹 48">
              <a:extLst>
                <a:ext uri="{FF2B5EF4-FFF2-40B4-BE49-F238E27FC236}">
                  <a16:creationId xmlns:a16="http://schemas.microsoft.com/office/drawing/2014/main" id="{4A684174-6ACF-43D5-8CF6-AE7B91E6CCB4}"/>
                </a:ext>
              </a:extLst>
            </p:cNvPr>
            <p:cNvGrpSpPr/>
            <p:nvPr/>
          </p:nvGrpSpPr>
          <p:grpSpPr>
            <a:xfrm>
              <a:off x="3439067" y="5375428"/>
              <a:ext cx="2079524" cy="1943934"/>
              <a:chOff x="3439067" y="5885968"/>
              <a:chExt cx="2079524" cy="1943934"/>
            </a:xfrm>
          </p:grpSpPr>
          <p:graphicFrame>
            <p:nvGraphicFramePr>
              <p:cNvPr id="40" name="차트 39">
                <a:extLst>
                  <a:ext uri="{FF2B5EF4-FFF2-40B4-BE49-F238E27FC236}">
                    <a16:creationId xmlns:a16="http://schemas.microsoft.com/office/drawing/2014/main" id="{D889D26C-1F15-41E5-94EF-4A5A29D34F8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756572328"/>
                  </p:ext>
                </p:extLst>
              </p:nvPr>
            </p:nvGraphicFramePr>
            <p:xfrm>
              <a:off x="3564397" y="5885968"/>
              <a:ext cx="1954194" cy="189992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198C3595-2213-4222-866D-0729949983CD}"/>
                  </a:ext>
                </a:extLst>
              </p:cNvPr>
              <p:cNvSpPr txBox="1"/>
              <p:nvPr/>
            </p:nvSpPr>
            <p:spPr>
              <a:xfrm rot="16200000">
                <a:off x="2925952" y="6628875"/>
                <a:ext cx="122628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ized Expression</a:t>
                </a:r>
              </a:p>
            </p:txBody>
          </p:sp>
          <p:grpSp>
            <p:nvGrpSpPr>
              <p:cNvPr id="50" name="그룹 49">
                <a:extLst>
                  <a:ext uri="{FF2B5EF4-FFF2-40B4-BE49-F238E27FC236}">
                    <a16:creationId xmlns:a16="http://schemas.microsoft.com/office/drawing/2014/main" id="{CFFDCA54-982B-4194-99F7-BE30E6059C76}"/>
                  </a:ext>
                </a:extLst>
              </p:cNvPr>
              <p:cNvGrpSpPr/>
              <p:nvPr/>
            </p:nvGrpSpPr>
            <p:grpSpPr>
              <a:xfrm>
                <a:off x="3758723" y="7627592"/>
                <a:ext cx="1178528" cy="202310"/>
                <a:chOff x="1288289" y="7612352"/>
                <a:chExt cx="1178528" cy="202310"/>
              </a:xfrm>
            </p:grpSpPr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B75B65BC-32AB-4783-A73A-D8A4AD5748EA}"/>
                    </a:ext>
                  </a:extLst>
                </p:cNvPr>
                <p:cNvSpPr txBox="1"/>
                <p:nvPr/>
              </p:nvSpPr>
              <p:spPr>
                <a:xfrm>
                  <a:off x="1288289" y="7612352"/>
                  <a:ext cx="1178528" cy="2023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veloping Seeds (DAP)</a:t>
                  </a:r>
                </a:p>
              </p:txBody>
            </p:sp>
            <p:cxnSp>
              <p:nvCxnSpPr>
                <p:cNvPr id="52" name="Straight Connector 9">
                  <a:extLst>
                    <a:ext uri="{FF2B5EF4-FFF2-40B4-BE49-F238E27FC236}">
                      <a16:creationId xmlns:a16="http://schemas.microsoft.com/office/drawing/2014/main" id="{125C8E85-F46A-49E1-B29C-020817F9208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94192" y="7612352"/>
                  <a:ext cx="73007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37" name="TextBox 36"/>
          <p:cNvSpPr txBox="1"/>
          <p:nvPr/>
        </p:nvSpPr>
        <p:spPr>
          <a:xfrm>
            <a:off x="421970" y="4983210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cs typeface="Arial" panose="020B0604020202020204" pitchFamily="34" charset="0"/>
              </a:rPr>
              <a:t>B</a:t>
            </a:r>
            <a:endParaRPr lang="ko-KR" altLang="en-US" sz="1600" dirty="0"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B145F81-7DFD-4341-8090-634A9E7B20C9}"/>
              </a:ext>
            </a:extLst>
          </p:cNvPr>
          <p:cNvSpPr txBox="1"/>
          <p:nvPr/>
        </p:nvSpPr>
        <p:spPr>
          <a:xfrm>
            <a:off x="4912659" y="231289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0398D63-51B0-46CC-9AFF-67AC001565F4}"/>
              </a:ext>
            </a:extLst>
          </p:cNvPr>
          <p:cNvSpPr txBox="1"/>
          <p:nvPr/>
        </p:nvSpPr>
        <p:spPr>
          <a:xfrm>
            <a:off x="5199530" y="2321860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D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28137E0-F463-4B00-BD36-ACBCEF3EBDB5}"/>
              </a:ext>
            </a:extLst>
          </p:cNvPr>
          <p:cNvSpPr txBox="1"/>
          <p:nvPr/>
        </p:nvSpPr>
        <p:spPr>
          <a:xfrm>
            <a:off x="5504330" y="2321859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D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62831" y="1003670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cs typeface="Arial" panose="020B0604020202020204" pitchFamily="34" charset="0"/>
              </a:rPr>
              <a:t>A</a:t>
            </a:r>
            <a:endParaRPr lang="ko-KR" altLang="en-US" sz="16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6095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0</TotalTime>
  <Words>286</Words>
  <Application>Microsoft Office PowerPoint</Application>
  <PresentationFormat>A4 Paper (210x297 mm)</PresentationFormat>
  <Paragraphs>1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Presentation</vt:lpstr>
    </vt:vector>
  </TitlesOfParts>
  <Company>L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 Hyun Uk</dc:creator>
  <cp:lastModifiedBy>Chen, Grace - ARS</cp:lastModifiedBy>
  <cp:revision>41</cp:revision>
  <dcterms:created xsi:type="dcterms:W3CDTF">2020-03-01T06:21:31Z</dcterms:created>
  <dcterms:modified xsi:type="dcterms:W3CDTF">2021-01-01T00:58:34Z</dcterms:modified>
</cp:coreProperties>
</file>